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1831557" y="11904437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3—figure supplement 3—source data 1. PowerPoint file containing original western blots for Figure 3—figure supplement 3b, indicating the relevant bands and treatments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7E1FF6AD-263E-44C8-9B96-62265C603A2F}"/>
              </a:ext>
            </a:extLst>
          </p:cNvPr>
          <p:cNvGrpSpPr/>
          <p:nvPr/>
        </p:nvGrpSpPr>
        <p:grpSpPr>
          <a:xfrm>
            <a:off x="5382726" y="4762464"/>
            <a:ext cx="5023315" cy="5429249"/>
            <a:chOff x="2380373" y="1969738"/>
            <a:chExt cx="4504521" cy="542925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C5A8F1D0-E976-48D4-9FB4-B7E3C0A3396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32848" y="1969738"/>
              <a:ext cx="3752046" cy="5181600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23EE0336-282A-48EC-BA2C-1704E15FC34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80373" y="1969738"/>
              <a:ext cx="752475" cy="5429250"/>
            </a:xfrm>
            <a:prstGeom prst="rect">
              <a:avLst/>
            </a:prstGeom>
          </p:spPr>
        </p:pic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C67B52A5-DAE3-46FB-B765-DDBDDB7F3611}"/>
              </a:ext>
            </a:extLst>
          </p:cNvPr>
          <p:cNvSpPr txBox="1"/>
          <p:nvPr/>
        </p:nvSpPr>
        <p:spPr>
          <a:xfrm rot="19637541">
            <a:off x="6356645" y="3181019"/>
            <a:ext cx="3831098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BD-</a:t>
            </a:r>
            <a:r>
              <a:rPr lang="en-US" altLang="zh-CN" sz="4001" dirty="0" err="1">
                <a:latin typeface="Arial" panose="020B0604020202020204" pitchFamily="34" charset="0"/>
                <a:cs typeface="Arial" panose="020B0604020202020204" pitchFamily="34" charset="0"/>
              </a:rPr>
              <a:t>BtFTSP</a:t>
            </a:r>
            <a:endParaRPr lang="zh-CN" altLang="en-US" sz="400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235C810-1833-4076-8742-4A6C0771F7BC}"/>
              </a:ext>
            </a:extLst>
          </p:cNvPr>
          <p:cNvSpPr txBox="1"/>
          <p:nvPr/>
        </p:nvSpPr>
        <p:spPr>
          <a:xfrm rot="19637541">
            <a:off x="7531386" y="3303977"/>
            <a:ext cx="3831098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BD-BtSP16.3</a:t>
            </a:r>
            <a:endParaRPr lang="zh-CN" altLang="en-US" sz="400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5F8AF6E-B224-4BA4-9D36-5D1A9F504927}"/>
              </a:ext>
            </a:extLst>
          </p:cNvPr>
          <p:cNvSpPr txBox="1"/>
          <p:nvPr/>
        </p:nvSpPr>
        <p:spPr>
          <a:xfrm rot="19637541">
            <a:off x="8912427" y="3183255"/>
            <a:ext cx="3831098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BD-BtSP37.4</a:t>
            </a:r>
            <a:endParaRPr lang="zh-CN" altLang="en-US" sz="400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4</Words>
  <Application>Microsoft Office PowerPoint</Application>
  <PresentationFormat>自定义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4</cp:revision>
  <dcterms:created xsi:type="dcterms:W3CDTF">2026-03-26T06:05:32Z</dcterms:created>
  <dcterms:modified xsi:type="dcterms:W3CDTF">2026-03-26T06:31:00Z</dcterms:modified>
</cp:coreProperties>
</file>